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5D2B155-23F6-408B-855A-42175B2F5D4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00ED28-5D43-466C-B507-E1E6D9F591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FEC30F-4F52-4218-9297-68B477EAD4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BEC3B6B-39F3-4666-8A5A-9C89EFD55348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25C738-106C-4366-9E80-9385B9EDC6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35AD82A-D7D2-42CA-B0A6-D169C97F0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CB11633-C854-4A59-A0A6-33D2651DC6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1713AA-B08A-44A5-AFB9-30AD3DB747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2FE57B8-7991-4D19-8689-23E44036DB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6301B3E-2B77-4634-B227-9774A5109B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9AB90F3-63FF-4985-895E-83BA7BE810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C77D209-FDCD-4269-B919-0BCAD567CB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2/2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C4FAD40-9939-4D79-A1AD-2F84E9BC1DDB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60200" y="1189080"/>
            <a:ext cx="6743880" cy="2316240"/>
            <a:chOff x="160200" y="1189080"/>
            <a:chExt cx="6743880" cy="2316240"/>
          </a:xfrm>
        </p:grpSpPr>
        <p:sp>
          <p:nvSpPr>
            <p:cNvPr id="42" name=""/>
            <p:cNvSpPr/>
            <p:nvPr/>
          </p:nvSpPr>
          <p:spPr>
            <a:xfrm rot="16200000">
              <a:off x="-68400" y="2637720"/>
              <a:ext cx="77796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Vimen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442520" y="1189080"/>
              <a:ext cx="114084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imary tum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650120" y="1189080"/>
              <a:ext cx="12978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ung metasta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2492280" y="1444680"/>
              <a:ext cx="1184400" cy="1973160"/>
              <a:chOff x="2492280" y="1444680"/>
              <a:chExt cx="1184400" cy="1973160"/>
            </a:xfrm>
          </p:grpSpPr>
          <p:pic>
            <p:nvPicPr>
              <p:cNvPr id="46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2492280" y="2324160"/>
                <a:ext cx="1184400" cy="1093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"/>
              <p:cNvSpPr/>
              <p:nvPr/>
            </p:nvSpPr>
            <p:spPr>
              <a:xfrm>
                <a:off x="2657520" y="1444680"/>
                <a:ext cx="861840" cy="72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tenfl/fl:p53fl/f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"/>
            <p:cNvGrpSpPr/>
            <p:nvPr/>
          </p:nvGrpSpPr>
          <p:grpSpPr>
            <a:xfrm>
              <a:off x="382680" y="1444680"/>
              <a:ext cx="2154240" cy="2060640"/>
              <a:chOff x="382680" y="1444680"/>
              <a:chExt cx="2154240" cy="2060640"/>
            </a:xfrm>
          </p:grpSpPr>
          <p:pic>
            <p:nvPicPr>
              <p:cNvPr id="49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82680" y="2252520"/>
                <a:ext cx="1184040" cy="1252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1352520" y="2252520"/>
                <a:ext cx="1184400" cy="1252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"/>
              <p:cNvSpPr/>
              <p:nvPr/>
            </p:nvSpPr>
            <p:spPr>
              <a:xfrm>
                <a:off x="455760" y="1444680"/>
                <a:ext cx="1060200" cy="101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 Ptenfl/fl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53R270H/wt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PD)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382760" y="1444680"/>
                <a:ext cx="1074600" cy="101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 Ptenfl/fl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53R270H/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Spindle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5719680" y="1436760"/>
              <a:ext cx="1184400" cy="1958760"/>
              <a:chOff x="5719680" y="1436760"/>
              <a:chExt cx="1184400" cy="1958760"/>
            </a:xfrm>
          </p:grpSpPr>
          <p:pic>
            <p:nvPicPr>
              <p:cNvPr id="54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5719680" y="2341440"/>
                <a:ext cx="1184400" cy="1054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"/>
              <p:cNvSpPr/>
              <p:nvPr/>
            </p:nvSpPr>
            <p:spPr>
              <a:xfrm>
                <a:off x="5905440" y="1436760"/>
                <a:ext cx="795240" cy="72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tenfl/fl:p53fl/f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"/>
            <p:cNvGrpSpPr/>
            <p:nvPr/>
          </p:nvGrpSpPr>
          <p:grpSpPr>
            <a:xfrm>
              <a:off x="3651120" y="1436760"/>
              <a:ext cx="2149560" cy="2062080"/>
              <a:chOff x="3651120" y="1436760"/>
              <a:chExt cx="2149560" cy="2062080"/>
            </a:xfrm>
          </p:grpSpPr>
          <p:pic>
            <p:nvPicPr>
              <p:cNvPr id="57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4616280" y="2257560"/>
                <a:ext cx="1184400" cy="1241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3651120" y="2257560"/>
                <a:ext cx="1184400" cy="1241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9" name=""/>
              <p:cNvSpPr/>
              <p:nvPr/>
            </p:nvSpPr>
            <p:spPr>
              <a:xfrm>
                <a:off x="3765600" y="1436760"/>
                <a:ext cx="1038240" cy="101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 Ptenfl/fl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53R270H/wt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PD)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4722840" y="1436760"/>
                <a:ext cx="1011240" cy="101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1440" anchor="t">
                <a:spAutoFit/>
              </a:bodyPr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AP-Cre: Ptenfl/fl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53R270H/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Aft>
                    <a:spcPts val="601"/>
                  </a:spcAft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Spindle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"/>
            <p:cNvSpPr/>
            <p:nvPr/>
          </p:nvSpPr>
          <p:spPr>
            <a:xfrm>
              <a:off x="404640" y="1436760"/>
              <a:ext cx="3165480" cy="1440"/>
            </a:xfrm>
            <a:prstGeom prst="line">
              <a:avLst/>
            </a:prstGeom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639960" y="1436760"/>
              <a:ext cx="3165480" cy="1440"/>
            </a:xfrm>
            <a:prstGeom prst="line">
              <a:avLst/>
            </a:prstGeom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636880" y="3581280"/>
            <a:ext cx="1219320" cy="16639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 algn="r">
              <a:lnSpc>
                <a:spcPct val="100000"/>
              </a:lnSpc>
              <a:buNone/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